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21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5" r:id="rId2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2094" y="-81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D55BB8-0C8D-4C45-A142-F448DBAABF28}" type="datetimeFigureOut">
              <a:rPr lang="en-CA" smtClean="0"/>
              <a:t>19/02/201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823546-0FC3-4032-8CB4-B164F223C33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782279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CE5560-D87C-434A-B62C-9F29E6192AAA}" type="datetime1">
              <a:rPr lang="en-CA" smtClean="0"/>
              <a:t>19/02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C3D82-EB7A-47D4-99CD-CCD4DEA305DE}" type="datetime1">
              <a:rPr lang="en-CA" smtClean="0"/>
              <a:t>19/02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62509-4278-4B83-A77E-6D0BA1FC0217}" type="datetime1">
              <a:rPr lang="en-CA" smtClean="0"/>
              <a:t>19/02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CF1B37-DF7F-4241-B2E8-08D6E779D019}" type="datetime1">
              <a:rPr lang="en-CA" smtClean="0"/>
              <a:t>19/02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C2F9EB-7954-41D3-9FB6-3C4DAE61F53B}" type="datetime1">
              <a:rPr lang="en-CA" smtClean="0"/>
              <a:t>19/02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C2AED-5A16-4FBD-B058-8CA7AF58787D}" type="datetime1">
              <a:rPr lang="en-CA" smtClean="0"/>
              <a:t>19/02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CBB58-07FF-414A-8D0C-12C7D4FF8BCB}" type="datetime1">
              <a:rPr lang="en-CA" smtClean="0"/>
              <a:t>19/02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860C0-EE01-4E74-B0A4-0D2ECF512374}" type="datetime1">
              <a:rPr lang="en-CA" smtClean="0"/>
              <a:t>19/02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7CE19F-32F6-4C94-AB13-467AE705EA62}" type="datetime1">
              <a:rPr lang="en-CA" smtClean="0"/>
              <a:t>19/02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7BE3EC-5A4F-4469-B2F4-F83AD6FA6CF0}" type="datetime1">
              <a:rPr lang="en-CA" smtClean="0"/>
              <a:t>19/02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078E6-DE73-4347-9E10-FD1A71200790}" type="datetime1">
              <a:rPr lang="en-CA" smtClean="0"/>
              <a:t>19/02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9E11C-9813-460B-8935-FDA39175ABA0}" type="datetime1">
              <a:rPr lang="en-CA" smtClean="0"/>
              <a:t>19/02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13186-8EBC-45F1-B67B-4C09B01D69AB}" type="slidenum">
              <a:rPr lang="en-CA" smtClean="0"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hyperlink" Target="http://www.healthscreen.com/" TargetMode="Externa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hyperlink" Target="http://www.optimedsoftware.com/index.php" TargetMode="Externa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hyperlink" Target="http://www.cerner.com/public/default.asp?id=18731" TargetMode="Externa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hyperlink" Target="http://www.abelsoft.com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CA" dirty="0" smtClean="0"/>
              <a:t>Multimedia Appendix </a:t>
            </a:r>
            <a:r>
              <a:rPr lang="en-CA" dirty="0" smtClean="0"/>
              <a:t>2</a:t>
            </a:r>
            <a:endParaRPr lang="en-CA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55576" y="3886200"/>
            <a:ext cx="7232848" cy="1752600"/>
          </a:xfrm>
        </p:spPr>
        <p:txBody>
          <a:bodyPr/>
          <a:lstStyle/>
          <a:p>
            <a:r>
              <a:rPr lang="en-CA" dirty="0" smtClean="0"/>
              <a:t>Screenshots of EHR vendor homepages </a:t>
            </a:r>
          </a:p>
          <a:p>
            <a:pPr>
              <a:spcBef>
                <a:spcPts val="0"/>
              </a:spcBef>
            </a:pPr>
            <a:r>
              <a:rPr lang="en-CA" dirty="0" smtClean="0"/>
              <a:t>(taken during data collection)</a:t>
            </a:r>
            <a:endParaRPr lang="en-CA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0</a:t>
            </a:fld>
            <a:endParaRPr lang="en-CA"/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Healthscreen</a:t>
            </a:r>
            <a:endParaRPr kumimoji="0" lang="en-CA" sz="4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6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HS Practice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healthscreen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19, 2010</a:t>
            </a:r>
          </a:p>
        </p:txBody>
      </p:sp>
      <p:sp>
        <p:nvSpPr>
          <p:cNvPr id="7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8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0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0" name="Picture 9" descr="healthscreen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71413" y="980728"/>
            <a:ext cx="7801174" cy="4752528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1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Jonoke</a:t>
            </a:r>
            <a:endParaRPr kumimoji="0" lang="en-CA" sz="4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</a:t>
            </a:r>
            <a:r>
              <a:rPr kumimoji="0" lang="en-CA" sz="32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JonokeMed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jonoke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19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jonoke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919165" y="936233"/>
            <a:ext cx="7305671" cy="4810671"/>
          </a:xfrm>
          <a:prstGeom prst="rect">
            <a:avLst/>
          </a:prstGeom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2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Nightingale</a:t>
            </a: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Nightingale On</a:t>
            </a:r>
            <a:r>
              <a:rPr kumimoji="0" lang="en-CA" sz="32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Demand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nightingalemd.ca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25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nightingale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83568" y="984489"/>
            <a:ext cx="7776864" cy="4704055"/>
          </a:xfrm>
          <a:prstGeom prst="rect">
            <a:avLst/>
          </a:prstGeom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3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Optimed</a:t>
            </a:r>
            <a:endParaRPr kumimoji="0" lang="en-CA" sz="4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</a:t>
            </a:r>
            <a:r>
              <a:rPr kumimoji="0" lang="en-CA" sz="32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Accuro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optimedsoftware.com/index.php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26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3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optimed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22885" y="980728"/>
            <a:ext cx="7098230" cy="4752528"/>
          </a:xfrm>
          <a:prstGeom prst="rect">
            <a:avLst/>
          </a:prstGeom>
        </p:spPr>
      </p:pic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4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OSCAR (McMaster University)</a:t>
            </a: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OSCAR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oscarcanada.org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21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4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mcmaster_oscar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94840" y="1268760"/>
            <a:ext cx="8354320" cy="4104456"/>
          </a:xfrm>
          <a:prstGeom prst="rect">
            <a:avLst/>
          </a:prstGeom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5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 &amp; P Data Systems</a:t>
            </a: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Clinic </a:t>
            </a:r>
            <a:r>
              <a:rPr lang="en-CA" sz="3200" dirty="0" smtClean="0"/>
              <a:t>Information Syste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p-pdata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28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5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ppdata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809836" y="893409"/>
            <a:ext cx="7524328" cy="4839847"/>
          </a:xfrm>
          <a:prstGeom prst="rect">
            <a:avLst/>
          </a:prstGeom>
        </p:spPr>
      </p:pic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6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4400" dirty="0" smtClean="0">
                <a:latin typeface="+mj-lt"/>
                <a:ea typeface="+mj-ea"/>
                <a:cs typeface="+mj-cs"/>
              </a:rPr>
              <a:t>Practice Solutions</a:t>
            </a:r>
            <a:endParaRPr kumimoji="0" lang="en-CA" sz="4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00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PS Suite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practicesolutions.ca/index.cfm/ci_id/47452/la_id/1.ht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24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6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PracticeSolns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513124" y="932574"/>
            <a:ext cx="6117753" cy="4800682"/>
          </a:xfrm>
          <a:prstGeom prst="rect">
            <a:avLst/>
          </a:prstGeom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7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QuadraMed</a:t>
            </a:r>
            <a:endParaRPr kumimoji="0" lang="en-CA" sz="4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QCPR (acute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quadramed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28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7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quadramed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295637" y="919326"/>
            <a:ext cx="6552727" cy="4832830"/>
          </a:xfrm>
          <a:prstGeom prst="rect">
            <a:avLst/>
          </a:prstGeom>
        </p:spPr>
      </p:pic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8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elus</a:t>
            </a:r>
            <a:r>
              <a:rPr kumimoji="0" lang="en-CA" sz="44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Health</a:t>
            </a:r>
            <a:endParaRPr kumimoji="0" lang="en-CA" sz="4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</a:t>
            </a:r>
            <a:r>
              <a:rPr kumimoji="0" lang="en-CA" sz="32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oacis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(acute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telushealth.com/en/default.aspx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29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8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telus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22623" y="936172"/>
            <a:ext cx="7098754" cy="4797084"/>
          </a:xfrm>
          <a:prstGeom prst="rect">
            <a:avLst/>
          </a:prstGeom>
        </p:spPr>
      </p:pic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19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York-Med</a:t>
            </a: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York-Med</a:t>
            </a:r>
            <a:r>
              <a:rPr kumimoji="0" lang="en-CA" sz="32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MD Suite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york-med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30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9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yorkmed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009981" y="885798"/>
            <a:ext cx="7124038" cy="485623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544" y="188640"/>
            <a:ext cx="8229600" cy="868958"/>
          </a:xfrm>
        </p:spPr>
        <p:txBody>
          <a:bodyPr/>
          <a:lstStyle/>
          <a:p>
            <a:r>
              <a:rPr lang="en-CA" dirty="0" err="1" smtClean="0"/>
              <a:t>ABELSoft</a:t>
            </a:r>
            <a:endParaRPr lang="en-CA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55576" y="5805264"/>
            <a:ext cx="7571184" cy="536923"/>
          </a:xfrm>
        </p:spPr>
        <p:txBody>
          <a:bodyPr>
            <a:normAutofit fontScale="47500" lnSpcReduction="20000"/>
          </a:bodyPr>
          <a:lstStyle/>
          <a:p>
            <a:pPr>
              <a:buNone/>
            </a:pPr>
            <a:r>
              <a:rPr lang="en-CA" dirty="0" smtClean="0"/>
              <a:t>EHR: </a:t>
            </a:r>
            <a:r>
              <a:rPr lang="en-CA" dirty="0" err="1" smtClean="0"/>
              <a:t>ABELMed</a:t>
            </a:r>
            <a:r>
              <a:rPr lang="en-CA" dirty="0" smtClean="0"/>
              <a:t> (primary care)</a:t>
            </a:r>
          </a:p>
          <a:p>
            <a:pPr>
              <a:buNone/>
            </a:pPr>
            <a:r>
              <a:rPr lang="en-CA" dirty="0" smtClean="0"/>
              <a:t>Source URL: </a:t>
            </a:r>
            <a:r>
              <a:rPr lang="en-CA" dirty="0" smtClean="0">
                <a:hlinkClick r:id="rId2"/>
              </a:rPr>
              <a:t>http://www.abelsoft.com</a:t>
            </a:r>
            <a:r>
              <a:rPr lang="en-CA" dirty="0" smtClean="0"/>
              <a:t>; taken on August 14, 2010</a:t>
            </a:r>
            <a:endParaRPr lang="en-CA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dirty="0" smtClean="0"/>
              <a:t>Multimedia Appendix A</a:t>
            </a:r>
            <a:endParaRPr lang="en-CA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2</a:t>
            </a:fld>
            <a:endParaRPr lang="en-CA"/>
          </a:p>
        </p:txBody>
      </p:sp>
      <p:pic>
        <p:nvPicPr>
          <p:cNvPr id="6" name="Picture 5" descr="abelsoft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280606" y="980728"/>
            <a:ext cx="6582789" cy="4752528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3</a:t>
            </a:fld>
            <a:endParaRPr lang="en-CA"/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lphaIT</a:t>
            </a:r>
            <a:endParaRPr kumimoji="0" lang="en-CA" sz="4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7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 vert="horz" lIns="91440" tIns="45720" rIns="91440" bIns="45720" rtlCol="0"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s: </a:t>
            </a:r>
            <a:r>
              <a:rPr kumimoji="0" lang="en-CA" sz="32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GlobeMed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(primary care), UHM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alpha-it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16, 2010</a:t>
            </a:r>
          </a:p>
        </p:txBody>
      </p:sp>
      <p:sp>
        <p:nvSpPr>
          <p:cNvPr id="8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9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1" name="Picture 10" descr="alphaIT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951083" y="980728"/>
            <a:ext cx="7241835" cy="4687661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4</a:t>
            </a:fld>
            <a:endParaRPr lang="en-CA"/>
          </a:p>
        </p:txBody>
      </p:sp>
      <p:sp>
        <p:nvSpPr>
          <p:cNvPr id="6" name="Title 1"/>
          <p:cNvSpPr>
            <a:spLocks noGrp="1"/>
          </p:cNvSpPr>
          <p:nvPr>
            <p:ph type="title"/>
          </p:nvPr>
        </p:nvSpPr>
        <p:spPr>
          <a:xfrm>
            <a:off x="467544" y="188640"/>
            <a:ext cx="8229600" cy="868958"/>
          </a:xfrm>
        </p:spPr>
        <p:txBody>
          <a:bodyPr/>
          <a:lstStyle/>
          <a:p>
            <a:r>
              <a:rPr lang="en-CA" dirty="0" smtClean="0"/>
              <a:t>B Sharp</a:t>
            </a:r>
            <a:endParaRPr lang="en-CA" dirty="0"/>
          </a:p>
        </p:txBody>
      </p:sp>
      <p:sp>
        <p:nvSpPr>
          <p:cNvPr id="7" name="Content Placeholder 2"/>
          <p:cNvSpPr>
            <a:spLocks noGrp="1"/>
          </p:cNvSpPr>
          <p:nvPr>
            <p:ph idx="1"/>
          </p:nvPr>
        </p:nvSpPr>
        <p:spPr>
          <a:xfrm>
            <a:off x="755576" y="5805264"/>
            <a:ext cx="7571184" cy="536923"/>
          </a:xfrm>
        </p:spPr>
        <p:txBody>
          <a:bodyPr>
            <a:normAutofit fontScale="47500" lnSpcReduction="20000"/>
          </a:bodyPr>
          <a:lstStyle/>
          <a:p>
            <a:pPr>
              <a:buNone/>
            </a:pPr>
            <a:r>
              <a:rPr lang="en-CA" dirty="0" smtClean="0"/>
              <a:t>EHR: B Care (acute care)</a:t>
            </a:r>
          </a:p>
          <a:p>
            <a:pPr>
              <a:buNone/>
            </a:pPr>
            <a:r>
              <a:rPr lang="en-CA" dirty="0" smtClean="0"/>
              <a:t>Source URL: </a:t>
            </a:r>
            <a:r>
              <a:rPr lang="en-CA" dirty="0" smtClean="0">
                <a:hlinkClick r:id="rId2"/>
              </a:rPr>
              <a:t>http://www.bsharp.com</a:t>
            </a:r>
            <a:r>
              <a:rPr lang="en-CA" dirty="0" smtClean="0"/>
              <a:t>; taken on August 16, 2010</a:t>
            </a:r>
            <a:endParaRPr lang="en-CA" dirty="0"/>
          </a:p>
        </p:txBody>
      </p:sp>
      <p:sp>
        <p:nvSpPr>
          <p:cNvPr id="8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9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3" name="Picture 12" descr="bsharp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39552" y="915134"/>
            <a:ext cx="7861977" cy="4818122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5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erner</a:t>
            </a: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</a:t>
            </a:r>
            <a:r>
              <a:rPr kumimoji="0" lang="en-CA" sz="32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PowerChart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EMR (acute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cerner.com</a:t>
            </a:r>
            <a:r>
              <a:rPr lang="en-CA" sz="3200" dirty="0" smtClean="0">
                <a:hlinkClick r:id="rId2"/>
              </a:rPr>
              <a:t>/public/</a:t>
            </a:r>
            <a:r>
              <a:rPr lang="en-CA" sz="3200" dirty="0" err="1" smtClean="0">
                <a:hlinkClick r:id="rId2"/>
              </a:rPr>
              <a:t>default.asp?id</a:t>
            </a:r>
            <a:r>
              <a:rPr lang="en-CA" sz="3200" dirty="0" smtClean="0">
                <a:hlinkClick r:id="rId2"/>
              </a:rPr>
              <a:t>=18731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16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cerner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698694" y="989028"/>
            <a:ext cx="7746613" cy="4744228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6</a:t>
            </a:fld>
            <a:endParaRPr lang="en-CA"/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linicare</a:t>
            </a:r>
            <a:endParaRPr kumimoji="0" lang="en-CA" sz="44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6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</a:t>
            </a:r>
            <a:r>
              <a:rPr kumimoji="0" lang="en-CA" sz="32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liteCare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clinicare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17, 2010</a:t>
            </a:r>
          </a:p>
        </p:txBody>
      </p:sp>
      <p:sp>
        <p:nvSpPr>
          <p:cNvPr id="7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8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10" name="Picture 9" descr="clinicare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547664" y="908720"/>
            <a:ext cx="6048672" cy="4843602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7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clipsys</a:t>
            </a: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Sunrise Ambulatory</a:t>
            </a:r>
            <a:r>
              <a:rPr kumimoji="0" lang="en-CA" sz="32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Care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(primary care), Sunrise Clinical</a:t>
            </a:r>
            <a:r>
              <a:rPr kumimoji="0" lang="en-CA" sz="32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 Manager (acute care)</a:t>
            </a:r>
            <a:endParaRPr kumimoji="0" lang="en-CA" sz="3200" b="0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eclipsys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17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7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eclipsys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32219" y="980728"/>
            <a:ext cx="8079562" cy="468052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8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MIS</a:t>
            </a: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EMIS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emis.ca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18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emis_home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544993" y="908720"/>
            <a:ext cx="6054015" cy="4824536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CA" smtClean="0"/>
              <a:t>Multimedia Appendix A</a:t>
            </a:r>
            <a:endParaRPr lang="en-CA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313186-8EBC-45F1-B67B-4C09B01D69AB}" type="slidenum">
              <a:rPr lang="en-CA" smtClean="0"/>
              <a:t>9</a:t>
            </a:fld>
            <a:endParaRPr lang="en-CA"/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467544" y="188640"/>
            <a:ext cx="8229600" cy="868958"/>
          </a:xfrm>
          <a:prstGeom prst="rect">
            <a:avLst/>
          </a:prstGeom>
        </p:spPr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GE Healthcare</a:t>
            </a:r>
          </a:p>
        </p:txBody>
      </p:sp>
      <p:sp>
        <p:nvSpPr>
          <p:cNvPr id="5" name="Content Placeholder 2"/>
          <p:cNvSpPr txBox="1">
            <a:spLocks/>
          </p:cNvSpPr>
          <p:nvPr/>
        </p:nvSpPr>
        <p:spPr>
          <a:xfrm>
            <a:off x="755576" y="5805264"/>
            <a:ext cx="7571184" cy="536923"/>
          </a:xfrm>
          <a:prstGeom prst="rect">
            <a:avLst/>
          </a:prstGeom>
        </p:spPr>
        <p:txBody>
          <a:bodyPr>
            <a:normAutofit fontScale="47500" lnSpcReduction="20000"/>
          </a:bodyPr>
          <a:lstStyle/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EHR: Centricity (primary care)</a:t>
            </a:r>
          </a:p>
          <a:p>
            <a:pPr marL="342900" marR="0" lvl="0" indent="-342900" algn="l" defTabSz="914400" rtl="0" eaLnBrk="1" fontAlgn="auto" latinLnBrk="0" hangingPunct="1">
              <a:lnSpc>
                <a:spcPct val="100000"/>
              </a:lnSpc>
              <a:spcBef>
                <a:spcPct val="20000"/>
              </a:spcBef>
              <a:spcAft>
                <a:spcPts val="0"/>
              </a:spcAft>
              <a:buClrTx/>
              <a:buSzTx/>
              <a:buFont typeface="Arial" pitchFamily="34" charset="0"/>
              <a:buNone/>
              <a:tabLst/>
              <a:defRPr/>
            </a:pP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Source URL: 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  <a:hlinkClick r:id="rId2"/>
              </a:rPr>
              <a:t>http://www.gehealthcare.com</a:t>
            </a:r>
            <a:r>
              <a:rPr kumimoji="0" lang="en-CA" sz="32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; taken on August 18, 2010</a:t>
            </a:r>
          </a:p>
        </p:txBody>
      </p:sp>
      <p:sp>
        <p:nvSpPr>
          <p:cNvPr id="6" name="Footer Placeholder 3"/>
          <p:cNvSpPr txBox="1">
            <a:spLocks/>
          </p:cNvSpPr>
          <p:nvPr/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Multimedia Appendix A</a:t>
            </a:r>
            <a:endParaRPr kumimoji="0" lang="en-CA" sz="1200" b="0" i="0" u="none" strike="noStrike" kern="1200" cap="none" spc="0" normalizeH="0" baseline="0" noProof="0" dirty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sp>
        <p:nvSpPr>
          <p:cNvPr id="7" name="Slide Number Placeholder 4"/>
          <p:cNvSpPr txBox="1">
            <a:spLocks/>
          </p:cNvSpPr>
          <p:nvPr/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E313186-8EBC-45F1-B67B-4C09B01D69AB}" type="slidenum">
              <a:rPr kumimoji="0" lang="en-CA" sz="1200" b="0" i="0" u="none" strike="noStrike" kern="1200" cap="none" spc="0" normalizeH="0" baseline="0" noProof="0" smtClean="0">
                <a:ln>
                  <a:noFill/>
                </a:ln>
                <a:solidFill>
                  <a:schemeClr val="tx1">
                    <a:tint val="75000"/>
                  </a:schemeClr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en-CA" sz="1200" b="0" i="0" u="none" strike="noStrike" kern="1200" cap="none" spc="0" normalizeH="0" baseline="0" noProof="0" smtClean="0">
              <a:ln>
                <a:noFill/>
              </a:ln>
              <a:solidFill>
                <a:schemeClr val="tx1">
                  <a:tint val="75000"/>
                </a:schemeClr>
              </a:solidFill>
              <a:effectLst/>
              <a:uLnTx/>
              <a:uFillTx/>
              <a:latin typeface="+mn-lt"/>
              <a:ea typeface="+mn-ea"/>
              <a:cs typeface="+mn-cs"/>
            </a:endParaRPr>
          </a:p>
        </p:txBody>
      </p:sp>
      <p:pic>
        <p:nvPicPr>
          <p:cNvPr id="9" name="Picture 8" descr="GE_USCentricity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961330" y="908720"/>
            <a:ext cx="7221341" cy="4824536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568</Words>
  <Application>Microsoft Office PowerPoint</Application>
  <PresentationFormat>On-screen Show (4:3)</PresentationFormat>
  <Paragraphs>127</Paragraphs>
  <Slides>1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0" baseType="lpstr">
      <vt:lpstr>Office Theme</vt:lpstr>
      <vt:lpstr>Multimedia Appendix 2</vt:lpstr>
      <vt:lpstr>ABELSoft</vt:lpstr>
      <vt:lpstr>PowerPoint Presentation</vt:lpstr>
      <vt:lpstr>B Sharp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ltimedia Appendix A</dc:title>
  <dc:creator>nat</dc:creator>
  <cp:lastModifiedBy>Aviv Shachak</cp:lastModifiedBy>
  <cp:revision>20</cp:revision>
  <dcterms:created xsi:type="dcterms:W3CDTF">2012-07-05T02:42:42Z</dcterms:created>
  <dcterms:modified xsi:type="dcterms:W3CDTF">2013-02-19T13:49:13Z</dcterms:modified>
</cp:coreProperties>
</file>